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1" r:id="rId2"/>
    <p:sldId id="262" r:id="rId3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 showGuides="1">
      <p:cViewPr varScale="1">
        <p:scale>
          <a:sx n="70" d="100"/>
          <a:sy n="70" d="100"/>
        </p:scale>
        <p:origin x="384" y="60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7491E0-85FC-43CF-B235-8E57D4FF2B52}" type="datetimeFigureOut">
              <a:rPr kumimoji="1" lang="ja-JP" altLang="en-US" smtClean="0"/>
              <a:t>2021/9/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4BDD2A-D203-49C0-B1AA-A6F558BD5D5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8299417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7491E0-85FC-43CF-B235-8E57D4FF2B52}" type="datetimeFigureOut">
              <a:rPr kumimoji="1" lang="ja-JP" altLang="en-US" smtClean="0"/>
              <a:t>2021/9/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4BDD2A-D203-49C0-B1AA-A6F558BD5D5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3743169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7491E0-85FC-43CF-B235-8E57D4FF2B52}" type="datetimeFigureOut">
              <a:rPr kumimoji="1" lang="ja-JP" altLang="en-US" smtClean="0"/>
              <a:t>2021/9/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4BDD2A-D203-49C0-B1AA-A6F558BD5D5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1228009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7491E0-85FC-43CF-B235-8E57D4FF2B52}" type="datetimeFigureOut">
              <a:rPr kumimoji="1" lang="ja-JP" altLang="en-US" smtClean="0"/>
              <a:t>2021/9/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4BDD2A-D203-49C0-B1AA-A6F558BD5D5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5013310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7491E0-85FC-43CF-B235-8E57D4FF2B52}" type="datetimeFigureOut">
              <a:rPr kumimoji="1" lang="ja-JP" altLang="en-US" smtClean="0"/>
              <a:t>2021/9/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4BDD2A-D203-49C0-B1AA-A6F558BD5D5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3434759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7491E0-85FC-43CF-B235-8E57D4FF2B52}" type="datetimeFigureOut">
              <a:rPr kumimoji="1" lang="ja-JP" altLang="en-US" smtClean="0"/>
              <a:t>2021/9/6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4BDD2A-D203-49C0-B1AA-A6F558BD5D5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6098955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7491E0-85FC-43CF-B235-8E57D4FF2B52}" type="datetimeFigureOut">
              <a:rPr kumimoji="1" lang="ja-JP" altLang="en-US" smtClean="0"/>
              <a:t>2021/9/6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4BDD2A-D203-49C0-B1AA-A6F558BD5D5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7077262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7491E0-85FC-43CF-B235-8E57D4FF2B52}" type="datetimeFigureOut">
              <a:rPr kumimoji="1" lang="ja-JP" altLang="en-US" smtClean="0"/>
              <a:t>2021/9/6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4BDD2A-D203-49C0-B1AA-A6F558BD5D5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3629543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7491E0-85FC-43CF-B235-8E57D4FF2B52}" type="datetimeFigureOut">
              <a:rPr kumimoji="1" lang="ja-JP" altLang="en-US" smtClean="0"/>
              <a:t>2021/9/6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4BDD2A-D203-49C0-B1AA-A6F558BD5D5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6338885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7491E0-85FC-43CF-B235-8E57D4FF2B52}" type="datetimeFigureOut">
              <a:rPr kumimoji="1" lang="ja-JP" altLang="en-US" smtClean="0"/>
              <a:t>2021/9/6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4BDD2A-D203-49C0-B1AA-A6F558BD5D5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6598216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7491E0-85FC-43CF-B235-8E57D4FF2B52}" type="datetimeFigureOut">
              <a:rPr kumimoji="1" lang="ja-JP" altLang="en-US" smtClean="0"/>
              <a:t>2021/9/6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4BDD2A-D203-49C0-B1AA-A6F558BD5D5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2788132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77491E0-85FC-43CF-B235-8E57D4FF2B52}" type="datetimeFigureOut">
              <a:rPr kumimoji="1" lang="ja-JP" altLang="en-US" smtClean="0"/>
              <a:t>2021/9/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34BDD2A-D203-49C0-B1AA-A6F558BD5D5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0724068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表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383770874"/>
              </p:ext>
            </p:extLst>
          </p:nvPr>
        </p:nvGraphicFramePr>
        <p:xfrm>
          <a:off x="2503964" y="1078710"/>
          <a:ext cx="7184072" cy="4700580"/>
        </p:xfrm>
        <a:graphic>
          <a:graphicData uri="http://schemas.openxmlformats.org/drawingml/2006/table">
            <a:tbl>
              <a:tblPr/>
              <a:tblGrid>
                <a:gridCol w="898009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898009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898009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898009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898009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898009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898009">
                  <a:extLst>
                    <a:ext uri="{9D8B030D-6E8A-4147-A177-3AD203B41FA5}">
                      <a16:colId xmlns:a16="http://schemas.microsoft.com/office/drawing/2014/main" val="20006"/>
                    </a:ext>
                  </a:extLst>
                </a:gridCol>
                <a:gridCol w="898009">
                  <a:extLst>
                    <a:ext uri="{9D8B030D-6E8A-4147-A177-3AD203B41FA5}">
                      <a16:colId xmlns:a16="http://schemas.microsoft.com/office/drawing/2014/main" val="20007"/>
                    </a:ext>
                  </a:extLst>
                </a:gridCol>
              </a:tblGrid>
              <a:tr h="235029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 dirty="0">
                          <a:solidFill>
                            <a:srgbClr val="40404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ABL1</a:t>
                      </a:r>
                    </a:p>
                  </a:txBody>
                  <a:tcPr marL="8368" marR="8368" marT="8368" marB="0" anchor="ctr">
                    <a:lnL>
                      <a:noFill/>
                    </a:lnL>
                    <a:lnR w="6350" cap="flat" cmpd="sng" algn="ctr">
                      <a:solidFill>
                        <a:srgbClr val="C3D1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9EEF2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>
                          <a:solidFill>
                            <a:srgbClr val="40404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BUB1B</a:t>
                      </a:r>
                    </a:p>
                  </a:txBody>
                  <a:tcPr marL="8368" marR="8368" marT="8368" marB="0" anchor="ctr">
                    <a:lnL w="6350" cap="flat" cmpd="sng" algn="ctr">
                      <a:solidFill>
                        <a:srgbClr val="C3D1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C3D1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9EEF2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>
                          <a:solidFill>
                            <a:srgbClr val="40404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DDR2</a:t>
                      </a:r>
                    </a:p>
                  </a:txBody>
                  <a:tcPr marL="8368" marR="8368" marT="8368" marB="0" anchor="ctr">
                    <a:lnL w="6350" cap="flat" cmpd="sng" algn="ctr">
                      <a:solidFill>
                        <a:srgbClr val="C3D1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C3D1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9EEF2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>
                          <a:solidFill>
                            <a:srgbClr val="40404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FGFR2</a:t>
                      </a:r>
                    </a:p>
                  </a:txBody>
                  <a:tcPr marL="8368" marR="8368" marT="8368" marB="0" anchor="ctr">
                    <a:lnL w="6350" cap="flat" cmpd="sng" algn="ctr">
                      <a:solidFill>
                        <a:srgbClr val="C3D1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C3D1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9EEF2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>
                          <a:solidFill>
                            <a:srgbClr val="40404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IDH2</a:t>
                      </a:r>
                    </a:p>
                  </a:txBody>
                  <a:tcPr marL="8368" marR="8368" marT="8368" marB="0" anchor="ctr">
                    <a:lnL w="6350" cap="flat" cmpd="sng" algn="ctr">
                      <a:solidFill>
                        <a:srgbClr val="C3D1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C3D1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9EEF2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>
                          <a:solidFill>
                            <a:srgbClr val="40404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MEN1</a:t>
                      </a:r>
                    </a:p>
                  </a:txBody>
                  <a:tcPr marL="8368" marR="8368" marT="8368" marB="0" anchor="ctr">
                    <a:lnL w="6350" cap="flat" cmpd="sng" algn="ctr">
                      <a:solidFill>
                        <a:srgbClr val="C3D1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C3D1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9EEF2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>
                          <a:solidFill>
                            <a:srgbClr val="40404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PDGFRA</a:t>
                      </a:r>
                    </a:p>
                  </a:txBody>
                  <a:tcPr marL="8368" marR="8368" marT="8368" marB="0" anchor="ctr">
                    <a:lnL w="6350" cap="flat" cmpd="sng" algn="ctr">
                      <a:solidFill>
                        <a:srgbClr val="C3D1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C3D1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9EEF2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>
                          <a:solidFill>
                            <a:srgbClr val="40404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SMARCA4</a:t>
                      </a:r>
                    </a:p>
                  </a:txBody>
                  <a:tcPr marL="8368" marR="8368" marT="8368" marB="0" anchor="ctr">
                    <a:lnL w="6350" cap="flat" cmpd="sng" algn="ctr">
                      <a:solidFill>
                        <a:srgbClr val="C3D1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9EEF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235029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 dirty="0">
                          <a:solidFill>
                            <a:srgbClr val="40404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AKT1</a:t>
                      </a:r>
                    </a:p>
                  </a:txBody>
                  <a:tcPr marL="8368" marR="8368" marT="8368" marB="0" anchor="ctr">
                    <a:lnL>
                      <a:noFill/>
                    </a:lnL>
                    <a:lnR w="6350" cap="flat" cmpd="sng" algn="ctr">
                      <a:solidFill>
                        <a:srgbClr val="C3D1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>
                          <a:solidFill>
                            <a:srgbClr val="40404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CARD11</a:t>
                      </a:r>
                    </a:p>
                  </a:txBody>
                  <a:tcPr marL="8368" marR="8368" marT="8368" marB="0" anchor="ctr">
                    <a:lnL w="6350" cap="flat" cmpd="sng" algn="ctr">
                      <a:solidFill>
                        <a:srgbClr val="C3D1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C3D1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>
                          <a:solidFill>
                            <a:srgbClr val="40404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DICER1</a:t>
                      </a:r>
                    </a:p>
                  </a:txBody>
                  <a:tcPr marL="8368" marR="8368" marT="8368" marB="0" anchor="ctr">
                    <a:lnL w="6350" cap="flat" cmpd="sng" algn="ctr">
                      <a:solidFill>
                        <a:srgbClr val="C3D1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C3D1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>
                          <a:solidFill>
                            <a:srgbClr val="40404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FGFR3</a:t>
                      </a:r>
                    </a:p>
                  </a:txBody>
                  <a:tcPr marL="8368" marR="8368" marT="8368" marB="0" anchor="ctr">
                    <a:lnL w="6350" cap="flat" cmpd="sng" algn="ctr">
                      <a:solidFill>
                        <a:srgbClr val="C3D1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C3D1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>
                          <a:solidFill>
                            <a:srgbClr val="40404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IKZF1</a:t>
                      </a:r>
                    </a:p>
                  </a:txBody>
                  <a:tcPr marL="8368" marR="8368" marT="8368" marB="0" anchor="ctr">
                    <a:lnL w="6350" cap="flat" cmpd="sng" algn="ctr">
                      <a:solidFill>
                        <a:srgbClr val="C3D1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C3D1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>
                          <a:solidFill>
                            <a:srgbClr val="40404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MET</a:t>
                      </a:r>
                    </a:p>
                  </a:txBody>
                  <a:tcPr marL="8368" marR="8368" marT="8368" marB="0" anchor="ctr">
                    <a:lnL w="6350" cap="flat" cmpd="sng" algn="ctr">
                      <a:solidFill>
                        <a:srgbClr val="C3D1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C3D1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>
                          <a:solidFill>
                            <a:srgbClr val="40404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PHF6</a:t>
                      </a:r>
                    </a:p>
                  </a:txBody>
                  <a:tcPr marL="8368" marR="8368" marT="8368" marB="0" anchor="ctr">
                    <a:lnL w="6350" cap="flat" cmpd="sng" algn="ctr">
                      <a:solidFill>
                        <a:srgbClr val="C3D1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C3D1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>
                          <a:solidFill>
                            <a:srgbClr val="40404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SMARCB1</a:t>
                      </a:r>
                    </a:p>
                  </a:txBody>
                  <a:tcPr marL="8368" marR="8368" marT="8368" marB="0" anchor="ctr">
                    <a:lnL w="6350" cap="flat" cmpd="sng" algn="ctr">
                      <a:solidFill>
                        <a:srgbClr val="C3D1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235029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>
                          <a:solidFill>
                            <a:srgbClr val="40404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AKT2</a:t>
                      </a:r>
                    </a:p>
                  </a:txBody>
                  <a:tcPr marL="8368" marR="8368" marT="8368" marB="0" anchor="ctr">
                    <a:lnL>
                      <a:noFill/>
                    </a:lnL>
                    <a:lnR w="6350" cap="flat" cmpd="sng" algn="ctr">
                      <a:solidFill>
                        <a:srgbClr val="C3D1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9EEF2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 dirty="0">
                          <a:solidFill>
                            <a:srgbClr val="40404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CBL</a:t>
                      </a:r>
                    </a:p>
                  </a:txBody>
                  <a:tcPr marL="8368" marR="8368" marT="8368" marB="0" anchor="ctr">
                    <a:lnL w="6350" cap="flat" cmpd="sng" algn="ctr">
                      <a:solidFill>
                        <a:srgbClr val="C3D1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C3D1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9EEF2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>
                          <a:solidFill>
                            <a:srgbClr val="40404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DNMT3A</a:t>
                      </a:r>
                    </a:p>
                  </a:txBody>
                  <a:tcPr marL="8368" marR="8368" marT="8368" marB="0" anchor="ctr">
                    <a:lnL w="6350" cap="flat" cmpd="sng" algn="ctr">
                      <a:solidFill>
                        <a:srgbClr val="C3D1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C3D1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9EEF2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>
                          <a:solidFill>
                            <a:srgbClr val="40404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FH</a:t>
                      </a:r>
                    </a:p>
                  </a:txBody>
                  <a:tcPr marL="8368" marR="8368" marT="8368" marB="0" anchor="ctr">
                    <a:lnL w="6350" cap="flat" cmpd="sng" algn="ctr">
                      <a:solidFill>
                        <a:srgbClr val="C3D1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C3D1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9EEF2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>
                          <a:solidFill>
                            <a:srgbClr val="40404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IL6ST</a:t>
                      </a:r>
                    </a:p>
                  </a:txBody>
                  <a:tcPr marL="8368" marR="8368" marT="8368" marB="0" anchor="ctr">
                    <a:lnL w="6350" cap="flat" cmpd="sng" algn="ctr">
                      <a:solidFill>
                        <a:srgbClr val="C3D1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C3D1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9EEF2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>
                          <a:solidFill>
                            <a:srgbClr val="40404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MLH1</a:t>
                      </a:r>
                    </a:p>
                  </a:txBody>
                  <a:tcPr marL="8368" marR="8368" marT="8368" marB="0" anchor="ctr">
                    <a:lnL w="6350" cap="flat" cmpd="sng" algn="ctr">
                      <a:solidFill>
                        <a:srgbClr val="C3D1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C3D1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9EEF2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>
                          <a:solidFill>
                            <a:srgbClr val="40404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PIK3CA</a:t>
                      </a:r>
                    </a:p>
                  </a:txBody>
                  <a:tcPr marL="8368" marR="8368" marT="8368" marB="0" anchor="ctr">
                    <a:lnL w="6350" cap="flat" cmpd="sng" algn="ctr">
                      <a:solidFill>
                        <a:srgbClr val="C3D1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C3D1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9EEF2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>
                          <a:solidFill>
                            <a:srgbClr val="40404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SMO</a:t>
                      </a:r>
                    </a:p>
                  </a:txBody>
                  <a:tcPr marL="8368" marR="8368" marT="8368" marB="0" anchor="ctr">
                    <a:lnL w="6350" cap="flat" cmpd="sng" algn="ctr">
                      <a:solidFill>
                        <a:srgbClr val="C3D1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9EEF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235029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>
                          <a:solidFill>
                            <a:srgbClr val="40404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ALK</a:t>
                      </a:r>
                    </a:p>
                  </a:txBody>
                  <a:tcPr marL="8368" marR="8368" marT="8368" marB="0" anchor="ctr">
                    <a:lnL>
                      <a:noFill/>
                    </a:lnL>
                    <a:lnR w="6350" cap="flat" cmpd="sng" algn="ctr">
                      <a:solidFill>
                        <a:srgbClr val="C3D1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>
                          <a:solidFill>
                            <a:srgbClr val="40404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CBLB</a:t>
                      </a:r>
                    </a:p>
                  </a:txBody>
                  <a:tcPr marL="8368" marR="8368" marT="8368" marB="0" anchor="ctr">
                    <a:lnL w="6350" cap="flat" cmpd="sng" algn="ctr">
                      <a:solidFill>
                        <a:srgbClr val="C3D1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C3D1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>
                          <a:solidFill>
                            <a:srgbClr val="40404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ECT2L</a:t>
                      </a:r>
                    </a:p>
                  </a:txBody>
                  <a:tcPr marL="8368" marR="8368" marT="8368" marB="0" anchor="ctr">
                    <a:lnL w="6350" cap="flat" cmpd="sng" algn="ctr">
                      <a:solidFill>
                        <a:srgbClr val="C3D1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C3D1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>
                          <a:solidFill>
                            <a:srgbClr val="40404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FLCN</a:t>
                      </a:r>
                    </a:p>
                  </a:txBody>
                  <a:tcPr marL="8368" marR="8368" marT="8368" marB="0" anchor="ctr">
                    <a:lnL w="6350" cap="flat" cmpd="sng" algn="ctr">
                      <a:solidFill>
                        <a:srgbClr val="C3D1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C3D1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>
                          <a:solidFill>
                            <a:srgbClr val="40404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IL7R</a:t>
                      </a:r>
                    </a:p>
                  </a:txBody>
                  <a:tcPr marL="8368" marR="8368" marT="8368" marB="0" anchor="ctr">
                    <a:lnL w="6350" cap="flat" cmpd="sng" algn="ctr">
                      <a:solidFill>
                        <a:srgbClr val="C3D1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C3D1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>
                          <a:solidFill>
                            <a:srgbClr val="40404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MSH2</a:t>
                      </a:r>
                    </a:p>
                  </a:txBody>
                  <a:tcPr marL="8368" marR="8368" marT="8368" marB="0" anchor="ctr">
                    <a:lnL w="6350" cap="flat" cmpd="sng" algn="ctr">
                      <a:solidFill>
                        <a:srgbClr val="C3D1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C3D1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>
                          <a:solidFill>
                            <a:srgbClr val="40404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PIK3R1</a:t>
                      </a:r>
                    </a:p>
                  </a:txBody>
                  <a:tcPr marL="8368" marR="8368" marT="8368" marB="0" anchor="ctr">
                    <a:lnL w="6350" cap="flat" cmpd="sng" algn="ctr">
                      <a:solidFill>
                        <a:srgbClr val="C3D1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C3D1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>
                          <a:solidFill>
                            <a:srgbClr val="40404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SPOP</a:t>
                      </a:r>
                    </a:p>
                  </a:txBody>
                  <a:tcPr marL="8368" marR="8368" marT="8368" marB="0" anchor="ctr">
                    <a:lnL w="6350" cap="flat" cmpd="sng" algn="ctr">
                      <a:solidFill>
                        <a:srgbClr val="C3D1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235029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>
                          <a:solidFill>
                            <a:srgbClr val="40404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AMER1</a:t>
                      </a:r>
                    </a:p>
                  </a:txBody>
                  <a:tcPr marL="8368" marR="8368" marT="8368" marB="0" anchor="ctr">
                    <a:lnL>
                      <a:noFill/>
                    </a:lnL>
                    <a:lnR w="6350" cap="flat" cmpd="sng" algn="ctr">
                      <a:solidFill>
                        <a:srgbClr val="C3D1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9EEF2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>
                          <a:solidFill>
                            <a:srgbClr val="40404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CD79A</a:t>
                      </a:r>
                    </a:p>
                  </a:txBody>
                  <a:tcPr marL="8368" marR="8368" marT="8368" marB="0" anchor="ctr">
                    <a:lnL w="6350" cap="flat" cmpd="sng" algn="ctr">
                      <a:solidFill>
                        <a:srgbClr val="C3D1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C3D1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9EEF2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>
                          <a:solidFill>
                            <a:srgbClr val="40404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EGFR</a:t>
                      </a:r>
                    </a:p>
                  </a:txBody>
                  <a:tcPr marL="8368" marR="8368" marT="8368" marB="0" anchor="ctr">
                    <a:lnL w="6350" cap="flat" cmpd="sng" algn="ctr">
                      <a:solidFill>
                        <a:srgbClr val="C3D1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C3D1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9EEF2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>
                          <a:solidFill>
                            <a:srgbClr val="40404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FLT3</a:t>
                      </a:r>
                    </a:p>
                  </a:txBody>
                  <a:tcPr marL="8368" marR="8368" marT="8368" marB="0" anchor="ctr">
                    <a:lnL w="6350" cap="flat" cmpd="sng" algn="ctr">
                      <a:solidFill>
                        <a:srgbClr val="C3D1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C3D1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9EEF2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>
                          <a:solidFill>
                            <a:srgbClr val="40404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JAK1</a:t>
                      </a:r>
                    </a:p>
                  </a:txBody>
                  <a:tcPr marL="8368" marR="8368" marT="8368" marB="0" anchor="ctr">
                    <a:lnL w="6350" cap="flat" cmpd="sng" algn="ctr">
                      <a:solidFill>
                        <a:srgbClr val="C3D1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C3D1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9EEF2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>
                          <a:solidFill>
                            <a:srgbClr val="40404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MSH6</a:t>
                      </a:r>
                    </a:p>
                  </a:txBody>
                  <a:tcPr marL="8368" marR="8368" marT="8368" marB="0" anchor="ctr">
                    <a:lnL w="6350" cap="flat" cmpd="sng" algn="ctr">
                      <a:solidFill>
                        <a:srgbClr val="C3D1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C3D1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9EEF2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>
                          <a:solidFill>
                            <a:srgbClr val="40404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PMS2</a:t>
                      </a:r>
                    </a:p>
                  </a:txBody>
                  <a:tcPr marL="8368" marR="8368" marT="8368" marB="0" anchor="ctr">
                    <a:lnL w="6350" cap="flat" cmpd="sng" algn="ctr">
                      <a:solidFill>
                        <a:srgbClr val="C3D1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C3D1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9EEF2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>
                          <a:solidFill>
                            <a:srgbClr val="40404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SRC</a:t>
                      </a:r>
                    </a:p>
                  </a:txBody>
                  <a:tcPr marL="8368" marR="8368" marT="8368" marB="0" anchor="ctr">
                    <a:lnL w="6350" cap="flat" cmpd="sng" algn="ctr">
                      <a:solidFill>
                        <a:srgbClr val="C3D1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9EEF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235029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>
                          <a:solidFill>
                            <a:srgbClr val="40404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APC</a:t>
                      </a:r>
                    </a:p>
                  </a:txBody>
                  <a:tcPr marL="8368" marR="8368" marT="8368" marB="0" anchor="ctr">
                    <a:lnL>
                      <a:noFill/>
                    </a:lnL>
                    <a:lnR w="6350" cap="flat" cmpd="sng" algn="ctr">
                      <a:solidFill>
                        <a:srgbClr val="C3D1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>
                          <a:solidFill>
                            <a:srgbClr val="40404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CD79B</a:t>
                      </a:r>
                    </a:p>
                  </a:txBody>
                  <a:tcPr marL="8368" marR="8368" marT="8368" marB="0" anchor="ctr">
                    <a:lnL w="6350" cap="flat" cmpd="sng" algn="ctr">
                      <a:solidFill>
                        <a:srgbClr val="C3D1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C3D1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>
                          <a:solidFill>
                            <a:srgbClr val="40404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EP300</a:t>
                      </a:r>
                    </a:p>
                  </a:txBody>
                  <a:tcPr marL="8368" marR="8368" marT="8368" marB="0" anchor="ctr">
                    <a:lnL w="6350" cap="flat" cmpd="sng" algn="ctr">
                      <a:solidFill>
                        <a:srgbClr val="C3D1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C3D1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>
                          <a:solidFill>
                            <a:srgbClr val="40404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FUBP1</a:t>
                      </a:r>
                    </a:p>
                  </a:txBody>
                  <a:tcPr marL="8368" marR="8368" marT="8368" marB="0" anchor="ctr">
                    <a:lnL w="6350" cap="flat" cmpd="sng" algn="ctr">
                      <a:solidFill>
                        <a:srgbClr val="C3D1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C3D1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>
                          <a:solidFill>
                            <a:srgbClr val="40404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JAK2</a:t>
                      </a:r>
                    </a:p>
                  </a:txBody>
                  <a:tcPr marL="8368" marR="8368" marT="8368" marB="0" anchor="ctr">
                    <a:lnL w="6350" cap="flat" cmpd="sng" algn="ctr">
                      <a:solidFill>
                        <a:srgbClr val="C3D1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C3D1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>
                          <a:solidFill>
                            <a:srgbClr val="40404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MTOR</a:t>
                      </a:r>
                    </a:p>
                  </a:txBody>
                  <a:tcPr marL="8368" marR="8368" marT="8368" marB="0" anchor="ctr">
                    <a:lnL w="6350" cap="flat" cmpd="sng" algn="ctr">
                      <a:solidFill>
                        <a:srgbClr val="C3D1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C3D1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>
                          <a:solidFill>
                            <a:srgbClr val="40404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PPP2R1A</a:t>
                      </a:r>
                    </a:p>
                  </a:txBody>
                  <a:tcPr marL="8368" marR="8368" marT="8368" marB="0" anchor="ctr">
                    <a:lnL w="6350" cap="flat" cmpd="sng" algn="ctr">
                      <a:solidFill>
                        <a:srgbClr val="C3D1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C3D1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>
                          <a:solidFill>
                            <a:srgbClr val="40404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STK11</a:t>
                      </a:r>
                    </a:p>
                  </a:txBody>
                  <a:tcPr marL="8368" marR="8368" marT="8368" marB="0" anchor="ctr">
                    <a:lnL w="6350" cap="flat" cmpd="sng" algn="ctr">
                      <a:solidFill>
                        <a:srgbClr val="C3D1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235029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>
                          <a:solidFill>
                            <a:srgbClr val="40404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AR</a:t>
                      </a:r>
                    </a:p>
                  </a:txBody>
                  <a:tcPr marL="8368" marR="8368" marT="8368" marB="0" anchor="ctr">
                    <a:lnL>
                      <a:noFill/>
                    </a:lnL>
                    <a:lnR w="6350" cap="flat" cmpd="sng" algn="ctr">
                      <a:solidFill>
                        <a:srgbClr val="C3D1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9EEF2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>
                          <a:solidFill>
                            <a:srgbClr val="40404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CDC73</a:t>
                      </a:r>
                    </a:p>
                  </a:txBody>
                  <a:tcPr marL="8368" marR="8368" marT="8368" marB="0" anchor="ctr">
                    <a:lnL w="6350" cap="flat" cmpd="sng" algn="ctr">
                      <a:solidFill>
                        <a:srgbClr val="C3D1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C3D1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9EEF2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>
                          <a:solidFill>
                            <a:srgbClr val="40404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EPCAM</a:t>
                      </a:r>
                    </a:p>
                  </a:txBody>
                  <a:tcPr marL="8368" marR="8368" marT="8368" marB="0" anchor="ctr">
                    <a:lnL w="6350" cap="flat" cmpd="sng" algn="ctr">
                      <a:solidFill>
                        <a:srgbClr val="C3D1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C3D1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9EEF2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>
                          <a:solidFill>
                            <a:srgbClr val="40404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GATA1</a:t>
                      </a:r>
                    </a:p>
                  </a:txBody>
                  <a:tcPr marL="8368" marR="8368" marT="8368" marB="0" anchor="ctr">
                    <a:lnL w="6350" cap="flat" cmpd="sng" algn="ctr">
                      <a:solidFill>
                        <a:srgbClr val="C3D1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C3D1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9EEF2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>
                          <a:solidFill>
                            <a:srgbClr val="40404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JAK3</a:t>
                      </a:r>
                    </a:p>
                  </a:txBody>
                  <a:tcPr marL="8368" marR="8368" marT="8368" marB="0" anchor="ctr">
                    <a:lnL w="6350" cap="flat" cmpd="sng" algn="ctr">
                      <a:solidFill>
                        <a:srgbClr val="C3D1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C3D1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9EEF2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>
                          <a:solidFill>
                            <a:srgbClr val="40404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MUTYH</a:t>
                      </a:r>
                    </a:p>
                  </a:txBody>
                  <a:tcPr marL="8368" marR="8368" marT="8368" marB="0" anchor="ctr">
                    <a:lnL w="6350" cap="flat" cmpd="sng" algn="ctr">
                      <a:solidFill>
                        <a:srgbClr val="C3D1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C3D1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9EEF2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>
                          <a:solidFill>
                            <a:srgbClr val="40404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PRDM1</a:t>
                      </a:r>
                    </a:p>
                  </a:txBody>
                  <a:tcPr marL="8368" marR="8368" marT="8368" marB="0" anchor="ctr">
                    <a:lnL w="6350" cap="flat" cmpd="sng" algn="ctr">
                      <a:solidFill>
                        <a:srgbClr val="C3D1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C3D1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9EEF2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>
                          <a:solidFill>
                            <a:srgbClr val="40404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SUFU</a:t>
                      </a:r>
                    </a:p>
                  </a:txBody>
                  <a:tcPr marL="8368" marR="8368" marT="8368" marB="0" anchor="ctr">
                    <a:lnL w="6350" cap="flat" cmpd="sng" algn="ctr">
                      <a:solidFill>
                        <a:srgbClr val="C3D1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9EEF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235029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>
                          <a:solidFill>
                            <a:srgbClr val="40404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ARID1A</a:t>
                      </a:r>
                    </a:p>
                  </a:txBody>
                  <a:tcPr marL="8368" marR="8368" marT="8368" marB="0" anchor="ctr">
                    <a:lnL>
                      <a:noFill/>
                    </a:lnL>
                    <a:lnR w="6350" cap="flat" cmpd="sng" algn="ctr">
                      <a:solidFill>
                        <a:srgbClr val="C3D1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>
                          <a:solidFill>
                            <a:srgbClr val="40404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CDH1</a:t>
                      </a:r>
                    </a:p>
                  </a:txBody>
                  <a:tcPr marL="8368" marR="8368" marT="8368" marB="0" anchor="ctr">
                    <a:lnL w="6350" cap="flat" cmpd="sng" algn="ctr">
                      <a:solidFill>
                        <a:srgbClr val="C3D1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C3D1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>
                          <a:solidFill>
                            <a:srgbClr val="40404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ERBB2</a:t>
                      </a:r>
                    </a:p>
                  </a:txBody>
                  <a:tcPr marL="8368" marR="8368" marT="8368" marB="0" anchor="ctr">
                    <a:lnL w="6350" cap="flat" cmpd="sng" algn="ctr">
                      <a:solidFill>
                        <a:srgbClr val="C3D1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C3D1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>
                          <a:solidFill>
                            <a:srgbClr val="40404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GATA2</a:t>
                      </a:r>
                    </a:p>
                  </a:txBody>
                  <a:tcPr marL="8368" marR="8368" marT="8368" marB="0" anchor="ctr">
                    <a:lnL w="6350" cap="flat" cmpd="sng" algn="ctr">
                      <a:solidFill>
                        <a:srgbClr val="C3D1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C3D1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>
                          <a:solidFill>
                            <a:srgbClr val="40404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KDM6A</a:t>
                      </a:r>
                    </a:p>
                  </a:txBody>
                  <a:tcPr marL="8368" marR="8368" marT="8368" marB="0" anchor="ctr">
                    <a:lnL w="6350" cap="flat" cmpd="sng" algn="ctr">
                      <a:solidFill>
                        <a:srgbClr val="C3D1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C3D1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>
                          <a:solidFill>
                            <a:srgbClr val="40404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MYC</a:t>
                      </a:r>
                    </a:p>
                  </a:txBody>
                  <a:tcPr marL="8368" marR="8368" marT="8368" marB="0" anchor="ctr">
                    <a:lnL w="6350" cap="flat" cmpd="sng" algn="ctr">
                      <a:solidFill>
                        <a:srgbClr val="C3D1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C3D1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>
                          <a:solidFill>
                            <a:srgbClr val="40404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PRKAR1A</a:t>
                      </a:r>
                    </a:p>
                  </a:txBody>
                  <a:tcPr marL="8368" marR="8368" marT="8368" marB="0" anchor="ctr">
                    <a:lnL w="6350" cap="flat" cmpd="sng" algn="ctr">
                      <a:solidFill>
                        <a:srgbClr val="C3D1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C3D1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>
                          <a:solidFill>
                            <a:srgbClr val="40404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TERT</a:t>
                      </a:r>
                    </a:p>
                  </a:txBody>
                  <a:tcPr marL="8368" marR="8368" marT="8368" marB="0" anchor="ctr">
                    <a:lnL w="6350" cap="flat" cmpd="sng" algn="ctr">
                      <a:solidFill>
                        <a:srgbClr val="C3D1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235029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>
                          <a:solidFill>
                            <a:srgbClr val="40404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ARID2</a:t>
                      </a:r>
                    </a:p>
                  </a:txBody>
                  <a:tcPr marL="8368" marR="8368" marT="8368" marB="0" anchor="ctr">
                    <a:lnL>
                      <a:noFill/>
                    </a:lnL>
                    <a:lnR w="6350" cap="flat" cmpd="sng" algn="ctr">
                      <a:solidFill>
                        <a:srgbClr val="C3D1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9EEF2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>
                          <a:solidFill>
                            <a:srgbClr val="40404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CDK12</a:t>
                      </a:r>
                    </a:p>
                  </a:txBody>
                  <a:tcPr marL="8368" marR="8368" marT="8368" marB="0" anchor="ctr">
                    <a:lnL w="6350" cap="flat" cmpd="sng" algn="ctr">
                      <a:solidFill>
                        <a:srgbClr val="C3D1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C3D1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9EEF2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>
                          <a:solidFill>
                            <a:srgbClr val="40404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ERBB3</a:t>
                      </a:r>
                    </a:p>
                  </a:txBody>
                  <a:tcPr marL="8368" marR="8368" marT="8368" marB="0" anchor="ctr">
                    <a:lnL w="6350" cap="flat" cmpd="sng" algn="ctr">
                      <a:solidFill>
                        <a:srgbClr val="C3D1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C3D1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9EEF2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>
                          <a:solidFill>
                            <a:srgbClr val="40404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GATA3</a:t>
                      </a:r>
                    </a:p>
                  </a:txBody>
                  <a:tcPr marL="8368" marR="8368" marT="8368" marB="0" anchor="ctr">
                    <a:lnL w="6350" cap="flat" cmpd="sng" algn="ctr">
                      <a:solidFill>
                        <a:srgbClr val="C3D1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C3D1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9EEF2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>
                          <a:solidFill>
                            <a:srgbClr val="40404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KDR</a:t>
                      </a:r>
                    </a:p>
                  </a:txBody>
                  <a:tcPr marL="8368" marR="8368" marT="8368" marB="0" anchor="ctr">
                    <a:lnL w="6350" cap="flat" cmpd="sng" algn="ctr">
                      <a:solidFill>
                        <a:srgbClr val="C3D1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C3D1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9EEF2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>
                          <a:solidFill>
                            <a:srgbClr val="40404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MYD88</a:t>
                      </a:r>
                    </a:p>
                  </a:txBody>
                  <a:tcPr marL="8368" marR="8368" marT="8368" marB="0" anchor="ctr">
                    <a:lnL w="6350" cap="flat" cmpd="sng" algn="ctr">
                      <a:solidFill>
                        <a:srgbClr val="C3D1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C3D1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9EEF2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>
                          <a:solidFill>
                            <a:srgbClr val="40404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PTCH1</a:t>
                      </a:r>
                    </a:p>
                  </a:txBody>
                  <a:tcPr marL="8368" marR="8368" marT="8368" marB="0" anchor="ctr">
                    <a:lnL w="6350" cap="flat" cmpd="sng" algn="ctr">
                      <a:solidFill>
                        <a:srgbClr val="C3D1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C3D1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9EEF2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>
                          <a:solidFill>
                            <a:srgbClr val="40404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TNFAIP3</a:t>
                      </a:r>
                    </a:p>
                  </a:txBody>
                  <a:tcPr marL="8368" marR="8368" marT="8368" marB="0" anchor="ctr">
                    <a:lnL w="6350" cap="flat" cmpd="sng" algn="ctr">
                      <a:solidFill>
                        <a:srgbClr val="C3D1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9EEF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235029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>
                          <a:solidFill>
                            <a:srgbClr val="40404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ASXL1</a:t>
                      </a:r>
                    </a:p>
                  </a:txBody>
                  <a:tcPr marL="8368" marR="8368" marT="8368" marB="0" anchor="ctr">
                    <a:lnL>
                      <a:noFill/>
                    </a:lnL>
                    <a:lnR w="6350" cap="flat" cmpd="sng" algn="ctr">
                      <a:solidFill>
                        <a:srgbClr val="C3D1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>
                          <a:solidFill>
                            <a:srgbClr val="40404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CDK4</a:t>
                      </a:r>
                    </a:p>
                  </a:txBody>
                  <a:tcPr marL="8368" marR="8368" marT="8368" marB="0" anchor="ctr">
                    <a:lnL w="6350" cap="flat" cmpd="sng" algn="ctr">
                      <a:solidFill>
                        <a:srgbClr val="C3D1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C3D1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>
                          <a:solidFill>
                            <a:srgbClr val="40404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ERBB4</a:t>
                      </a:r>
                    </a:p>
                  </a:txBody>
                  <a:tcPr marL="8368" marR="8368" marT="8368" marB="0" anchor="ctr">
                    <a:lnL w="6350" cap="flat" cmpd="sng" algn="ctr">
                      <a:solidFill>
                        <a:srgbClr val="C3D1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C3D1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>
                          <a:solidFill>
                            <a:srgbClr val="40404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GNA11</a:t>
                      </a:r>
                    </a:p>
                  </a:txBody>
                  <a:tcPr marL="8368" marR="8368" marT="8368" marB="0" anchor="ctr">
                    <a:lnL w="6350" cap="flat" cmpd="sng" algn="ctr">
                      <a:solidFill>
                        <a:srgbClr val="C3D1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C3D1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>
                          <a:solidFill>
                            <a:srgbClr val="40404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KIT</a:t>
                      </a:r>
                    </a:p>
                  </a:txBody>
                  <a:tcPr marL="8368" marR="8368" marT="8368" marB="0" anchor="ctr">
                    <a:lnL w="6350" cap="flat" cmpd="sng" algn="ctr">
                      <a:solidFill>
                        <a:srgbClr val="C3D1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C3D1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>
                          <a:solidFill>
                            <a:srgbClr val="40404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NF1</a:t>
                      </a:r>
                    </a:p>
                  </a:txBody>
                  <a:tcPr marL="8368" marR="8368" marT="8368" marB="0" anchor="ctr">
                    <a:lnL w="6350" cap="flat" cmpd="sng" algn="ctr">
                      <a:solidFill>
                        <a:srgbClr val="C3D1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C3D1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>
                          <a:solidFill>
                            <a:srgbClr val="40404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PTEN</a:t>
                      </a:r>
                    </a:p>
                  </a:txBody>
                  <a:tcPr marL="8368" marR="8368" marT="8368" marB="0" anchor="ctr">
                    <a:lnL w="6350" cap="flat" cmpd="sng" algn="ctr">
                      <a:solidFill>
                        <a:srgbClr val="C3D1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C3D1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>
                          <a:solidFill>
                            <a:srgbClr val="40404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TNFRSF14</a:t>
                      </a:r>
                    </a:p>
                  </a:txBody>
                  <a:tcPr marL="8368" marR="8368" marT="8368" marB="0" anchor="ctr">
                    <a:lnL w="6350" cap="flat" cmpd="sng" algn="ctr">
                      <a:solidFill>
                        <a:srgbClr val="C3D1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235029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>
                          <a:solidFill>
                            <a:srgbClr val="40404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ATM</a:t>
                      </a:r>
                    </a:p>
                  </a:txBody>
                  <a:tcPr marL="8368" marR="8368" marT="8368" marB="0" anchor="ctr">
                    <a:lnL>
                      <a:noFill/>
                    </a:lnL>
                    <a:lnR w="6350" cap="flat" cmpd="sng" algn="ctr">
                      <a:solidFill>
                        <a:srgbClr val="C3D1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9EEF2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>
                          <a:solidFill>
                            <a:srgbClr val="40404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CDKN2A</a:t>
                      </a:r>
                    </a:p>
                  </a:txBody>
                  <a:tcPr marL="8368" marR="8368" marT="8368" marB="0" anchor="ctr">
                    <a:lnL w="6350" cap="flat" cmpd="sng" algn="ctr">
                      <a:solidFill>
                        <a:srgbClr val="C3D1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C3D1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9EEF2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>
                          <a:solidFill>
                            <a:srgbClr val="40404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ERCC5</a:t>
                      </a:r>
                    </a:p>
                  </a:txBody>
                  <a:tcPr marL="8368" marR="8368" marT="8368" marB="0" anchor="ctr">
                    <a:lnL w="6350" cap="flat" cmpd="sng" algn="ctr">
                      <a:solidFill>
                        <a:srgbClr val="C3D1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C3D1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9EEF2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>
                          <a:solidFill>
                            <a:srgbClr val="40404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GNAQ</a:t>
                      </a:r>
                    </a:p>
                  </a:txBody>
                  <a:tcPr marL="8368" marR="8368" marT="8368" marB="0" anchor="ctr">
                    <a:lnL w="6350" cap="flat" cmpd="sng" algn="ctr">
                      <a:solidFill>
                        <a:srgbClr val="C3D1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C3D1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9EEF2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>
                          <a:solidFill>
                            <a:srgbClr val="40404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KLF6</a:t>
                      </a:r>
                    </a:p>
                  </a:txBody>
                  <a:tcPr marL="8368" marR="8368" marT="8368" marB="0" anchor="ctr">
                    <a:lnL w="6350" cap="flat" cmpd="sng" algn="ctr">
                      <a:solidFill>
                        <a:srgbClr val="C3D1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C3D1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9EEF2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>
                          <a:solidFill>
                            <a:srgbClr val="40404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NF2</a:t>
                      </a:r>
                    </a:p>
                  </a:txBody>
                  <a:tcPr marL="8368" marR="8368" marT="8368" marB="0" anchor="ctr">
                    <a:lnL w="6350" cap="flat" cmpd="sng" algn="ctr">
                      <a:solidFill>
                        <a:srgbClr val="C3D1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C3D1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9EEF2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>
                          <a:solidFill>
                            <a:srgbClr val="40404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PTPN11</a:t>
                      </a:r>
                    </a:p>
                  </a:txBody>
                  <a:tcPr marL="8368" marR="8368" marT="8368" marB="0" anchor="ctr">
                    <a:lnL w="6350" cap="flat" cmpd="sng" algn="ctr">
                      <a:solidFill>
                        <a:srgbClr val="C3D1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C3D1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9EEF2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>
                          <a:solidFill>
                            <a:srgbClr val="40404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TP53</a:t>
                      </a:r>
                    </a:p>
                  </a:txBody>
                  <a:tcPr marL="8368" marR="8368" marT="8368" marB="0" anchor="ctr">
                    <a:lnL w="6350" cap="flat" cmpd="sng" algn="ctr">
                      <a:solidFill>
                        <a:srgbClr val="C3D1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9EEF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235029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>
                          <a:solidFill>
                            <a:srgbClr val="40404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ATRX</a:t>
                      </a:r>
                    </a:p>
                  </a:txBody>
                  <a:tcPr marL="8368" marR="8368" marT="8368" marB="0" anchor="ctr">
                    <a:lnL>
                      <a:noFill/>
                    </a:lnL>
                    <a:lnR w="6350" cap="flat" cmpd="sng" algn="ctr">
                      <a:solidFill>
                        <a:srgbClr val="C3D1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>
                          <a:solidFill>
                            <a:srgbClr val="40404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CHEK2</a:t>
                      </a:r>
                    </a:p>
                  </a:txBody>
                  <a:tcPr marL="8368" marR="8368" marT="8368" marB="0" anchor="ctr">
                    <a:lnL w="6350" cap="flat" cmpd="sng" algn="ctr">
                      <a:solidFill>
                        <a:srgbClr val="C3D1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C3D1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>
                          <a:solidFill>
                            <a:srgbClr val="40404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ESR1</a:t>
                      </a:r>
                    </a:p>
                  </a:txBody>
                  <a:tcPr marL="8368" marR="8368" marT="8368" marB="0" anchor="ctr">
                    <a:lnL w="6350" cap="flat" cmpd="sng" algn="ctr">
                      <a:solidFill>
                        <a:srgbClr val="C3D1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C3D1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>
                          <a:solidFill>
                            <a:srgbClr val="40404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GNAS</a:t>
                      </a:r>
                    </a:p>
                  </a:txBody>
                  <a:tcPr marL="8368" marR="8368" marT="8368" marB="0" anchor="ctr">
                    <a:lnL w="6350" cap="flat" cmpd="sng" algn="ctr">
                      <a:solidFill>
                        <a:srgbClr val="C3D1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C3D1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>
                          <a:solidFill>
                            <a:srgbClr val="40404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KMT2D</a:t>
                      </a:r>
                    </a:p>
                  </a:txBody>
                  <a:tcPr marL="8368" marR="8368" marT="8368" marB="0" anchor="ctr">
                    <a:lnL w="6350" cap="flat" cmpd="sng" algn="ctr">
                      <a:solidFill>
                        <a:srgbClr val="C3D1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C3D1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>
                          <a:solidFill>
                            <a:srgbClr val="40404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NFE2L2</a:t>
                      </a:r>
                    </a:p>
                  </a:txBody>
                  <a:tcPr marL="8368" marR="8368" marT="8368" marB="0" anchor="ctr">
                    <a:lnL w="6350" cap="flat" cmpd="sng" algn="ctr">
                      <a:solidFill>
                        <a:srgbClr val="C3D1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C3D1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>
                          <a:solidFill>
                            <a:srgbClr val="40404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RAC1</a:t>
                      </a:r>
                    </a:p>
                  </a:txBody>
                  <a:tcPr marL="8368" marR="8368" marT="8368" marB="0" anchor="ctr">
                    <a:lnL w="6350" cap="flat" cmpd="sng" algn="ctr">
                      <a:solidFill>
                        <a:srgbClr val="C3D1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C3D1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>
                          <a:solidFill>
                            <a:srgbClr val="40404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TSC1</a:t>
                      </a:r>
                    </a:p>
                  </a:txBody>
                  <a:tcPr marL="8368" marR="8368" marT="8368" marB="0" anchor="ctr">
                    <a:lnL w="6350" cap="flat" cmpd="sng" algn="ctr">
                      <a:solidFill>
                        <a:srgbClr val="C3D1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235029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>
                          <a:solidFill>
                            <a:srgbClr val="40404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BAP1</a:t>
                      </a:r>
                    </a:p>
                  </a:txBody>
                  <a:tcPr marL="8368" marR="8368" marT="8368" marB="0" anchor="ctr">
                    <a:lnL>
                      <a:noFill/>
                    </a:lnL>
                    <a:lnR w="6350" cap="flat" cmpd="sng" algn="ctr">
                      <a:solidFill>
                        <a:srgbClr val="C3D1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9EEF2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>
                          <a:solidFill>
                            <a:srgbClr val="40404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CIC</a:t>
                      </a:r>
                    </a:p>
                  </a:txBody>
                  <a:tcPr marL="8368" marR="8368" marT="8368" marB="0" anchor="ctr">
                    <a:lnL w="6350" cap="flat" cmpd="sng" algn="ctr">
                      <a:solidFill>
                        <a:srgbClr val="C3D1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C3D1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9EEF2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>
                          <a:solidFill>
                            <a:srgbClr val="40404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EZH2</a:t>
                      </a:r>
                    </a:p>
                  </a:txBody>
                  <a:tcPr marL="8368" marR="8368" marT="8368" marB="0" anchor="ctr">
                    <a:lnL w="6350" cap="flat" cmpd="sng" algn="ctr">
                      <a:solidFill>
                        <a:srgbClr val="C3D1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C3D1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9EEF2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>
                          <a:solidFill>
                            <a:srgbClr val="40404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GPC3</a:t>
                      </a:r>
                    </a:p>
                  </a:txBody>
                  <a:tcPr marL="8368" marR="8368" marT="8368" marB="0" anchor="ctr">
                    <a:lnL w="6350" cap="flat" cmpd="sng" algn="ctr">
                      <a:solidFill>
                        <a:srgbClr val="C3D1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C3D1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9EEF2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>
                          <a:solidFill>
                            <a:srgbClr val="40404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KRAS</a:t>
                      </a:r>
                    </a:p>
                  </a:txBody>
                  <a:tcPr marL="8368" marR="8368" marT="8368" marB="0" anchor="ctr">
                    <a:lnL w="6350" cap="flat" cmpd="sng" algn="ctr">
                      <a:solidFill>
                        <a:srgbClr val="C3D1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C3D1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9EEF2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>
                          <a:solidFill>
                            <a:srgbClr val="40404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NFKBIA</a:t>
                      </a:r>
                    </a:p>
                  </a:txBody>
                  <a:tcPr marL="8368" marR="8368" marT="8368" marB="0" anchor="ctr">
                    <a:lnL w="6350" cap="flat" cmpd="sng" algn="ctr">
                      <a:solidFill>
                        <a:srgbClr val="C3D1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C3D1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9EEF2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>
                          <a:solidFill>
                            <a:srgbClr val="40404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RB1</a:t>
                      </a:r>
                    </a:p>
                  </a:txBody>
                  <a:tcPr marL="8368" marR="8368" marT="8368" marB="0" anchor="ctr">
                    <a:lnL w="6350" cap="flat" cmpd="sng" algn="ctr">
                      <a:solidFill>
                        <a:srgbClr val="C3D1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C3D1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9EEF2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>
                          <a:solidFill>
                            <a:srgbClr val="40404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TSC2</a:t>
                      </a:r>
                    </a:p>
                  </a:txBody>
                  <a:tcPr marL="8368" marR="8368" marT="8368" marB="0" anchor="ctr">
                    <a:lnL w="6350" cap="flat" cmpd="sng" algn="ctr">
                      <a:solidFill>
                        <a:srgbClr val="C3D1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9EEF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  <a:tr h="235029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>
                          <a:solidFill>
                            <a:srgbClr val="40404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BCL6</a:t>
                      </a:r>
                    </a:p>
                  </a:txBody>
                  <a:tcPr marL="8368" marR="8368" marT="8368" marB="0" anchor="ctr">
                    <a:lnL>
                      <a:noFill/>
                    </a:lnL>
                    <a:lnR w="6350" cap="flat" cmpd="sng" algn="ctr">
                      <a:solidFill>
                        <a:srgbClr val="C3D1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>
                          <a:solidFill>
                            <a:srgbClr val="40404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CREBBP</a:t>
                      </a:r>
                    </a:p>
                  </a:txBody>
                  <a:tcPr marL="8368" marR="8368" marT="8368" marB="0" anchor="ctr">
                    <a:lnL w="6350" cap="flat" cmpd="sng" algn="ctr">
                      <a:solidFill>
                        <a:srgbClr val="C3D1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C3D1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>
                          <a:solidFill>
                            <a:srgbClr val="40404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FAM46C</a:t>
                      </a:r>
                    </a:p>
                  </a:txBody>
                  <a:tcPr marL="8368" marR="8368" marT="8368" marB="0" anchor="ctr">
                    <a:lnL w="6350" cap="flat" cmpd="sng" algn="ctr">
                      <a:solidFill>
                        <a:srgbClr val="C3D1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C3D1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>
                          <a:solidFill>
                            <a:srgbClr val="40404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GRIN2A</a:t>
                      </a:r>
                    </a:p>
                  </a:txBody>
                  <a:tcPr marL="8368" marR="8368" marT="8368" marB="0" anchor="ctr">
                    <a:lnL w="6350" cap="flat" cmpd="sng" algn="ctr">
                      <a:solidFill>
                        <a:srgbClr val="C3D1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C3D1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>
                          <a:solidFill>
                            <a:srgbClr val="40404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MAP2K1</a:t>
                      </a:r>
                    </a:p>
                  </a:txBody>
                  <a:tcPr marL="8368" marR="8368" marT="8368" marB="0" anchor="ctr">
                    <a:lnL w="6350" cap="flat" cmpd="sng" algn="ctr">
                      <a:solidFill>
                        <a:srgbClr val="C3D1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C3D1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>
                          <a:solidFill>
                            <a:srgbClr val="40404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NOTCH1</a:t>
                      </a:r>
                    </a:p>
                  </a:txBody>
                  <a:tcPr marL="8368" marR="8368" marT="8368" marB="0" anchor="ctr">
                    <a:lnL w="6350" cap="flat" cmpd="sng" algn="ctr">
                      <a:solidFill>
                        <a:srgbClr val="C3D1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C3D1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>
                          <a:solidFill>
                            <a:srgbClr val="40404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RET</a:t>
                      </a:r>
                    </a:p>
                  </a:txBody>
                  <a:tcPr marL="8368" marR="8368" marT="8368" marB="0" anchor="ctr">
                    <a:lnL w="6350" cap="flat" cmpd="sng" algn="ctr">
                      <a:solidFill>
                        <a:srgbClr val="C3D1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C3D1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>
                          <a:solidFill>
                            <a:srgbClr val="40404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TSHR</a:t>
                      </a:r>
                    </a:p>
                  </a:txBody>
                  <a:tcPr marL="8368" marR="8368" marT="8368" marB="0" anchor="ctr">
                    <a:lnL w="6350" cap="flat" cmpd="sng" algn="ctr">
                      <a:solidFill>
                        <a:srgbClr val="C3D1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3"/>
                  </a:ext>
                </a:extLst>
              </a:tr>
              <a:tr h="235029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>
                          <a:solidFill>
                            <a:srgbClr val="40404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BCOR</a:t>
                      </a:r>
                    </a:p>
                  </a:txBody>
                  <a:tcPr marL="8368" marR="8368" marT="8368" marB="0" anchor="ctr">
                    <a:lnL>
                      <a:noFill/>
                    </a:lnL>
                    <a:lnR w="6350" cap="flat" cmpd="sng" algn="ctr">
                      <a:solidFill>
                        <a:srgbClr val="C3D1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9EEF2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>
                          <a:solidFill>
                            <a:srgbClr val="40404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CRLF2</a:t>
                      </a:r>
                    </a:p>
                  </a:txBody>
                  <a:tcPr marL="8368" marR="8368" marT="8368" marB="0" anchor="ctr">
                    <a:lnL w="6350" cap="flat" cmpd="sng" algn="ctr">
                      <a:solidFill>
                        <a:srgbClr val="C3D1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C3D1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9EEF2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>
                          <a:solidFill>
                            <a:srgbClr val="40404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FANCA</a:t>
                      </a:r>
                    </a:p>
                  </a:txBody>
                  <a:tcPr marL="8368" marR="8368" marT="8368" marB="0" anchor="ctr">
                    <a:lnL w="6350" cap="flat" cmpd="sng" algn="ctr">
                      <a:solidFill>
                        <a:srgbClr val="C3D1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C3D1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9EEF2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>
                          <a:solidFill>
                            <a:srgbClr val="40404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H3F3A</a:t>
                      </a:r>
                    </a:p>
                  </a:txBody>
                  <a:tcPr marL="8368" marR="8368" marT="8368" marB="0" anchor="ctr">
                    <a:lnL w="6350" cap="flat" cmpd="sng" algn="ctr">
                      <a:solidFill>
                        <a:srgbClr val="C3D1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C3D1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9EEF2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>
                          <a:solidFill>
                            <a:srgbClr val="40404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MAP2K2</a:t>
                      </a:r>
                    </a:p>
                  </a:txBody>
                  <a:tcPr marL="8368" marR="8368" marT="8368" marB="0" anchor="ctr">
                    <a:lnL w="6350" cap="flat" cmpd="sng" algn="ctr">
                      <a:solidFill>
                        <a:srgbClr val="C3D1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C3D1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9EEF2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>
                          <a:solidFill>
                            <a:srgbClr val="40404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NOTCH2</a:t>
                      </a:r>
                    </a:p>
                  </a:txBody>
                  <a:tcPr marL="8368" marR="8368" marT="8368" marB="0" anchor="ctr">
                    <a:lnL w="6350" cap="flat" cmpd="sng" algn="ctr">
                      <a:solidFill>
                        <a:srgbClr val="C3D1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C3D1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9EEF2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>
                          <a:solidFill>
                            <a:srgbClr val="40404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ROS1</a:t>
                      </a:r>
                    </a:p>
                  </a:txBody>
                  <a:tcPr marL="8368" marR="8368" marT="8368" marB="0" anchor="ctr">
                    <a:lnL w="6350" cap="flat" cmpd="sng" algn="ctr">
                      <a:solidFill>
                        <a:srgbClr val="C3D1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C3D1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9EEF2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>
                          <a:solidFill>
                            <a:srgbClr val="40404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U2AF1</a:t>
                      </a:r>
                    </a:p>
                  </a:txBody>
                  <a:tcPr marL="8368" marR="8368" marT="8368" marB="0" anchor="ctr">
                    <a:lnL w="6350" cap="flat" cmpd="sng" algn="ctr">
                      <a:solidFill>
                        <a:srgbClr val="C3D1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9EEF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4"/>
                  </a:ext>
                </a:extLst>
              </a:tr>
              <a:tr h="235029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>
                          <a:solidFill>
                            <a:srgbClr val="40404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BRAF</a:t>
                      </a:r>
                    </a:p>
                  </a:txBody>
                  <a:tcPr marL="8368" marR="8368" marT="8368" marB="0" anchor="ctr">
                    <a:lnL>
                      <a:noFill/>
                    </a:lnL>
                    <a:lnR w="6350" cap="flat" cmpd="sng" algn="ctr">
                      <a:solidFill>
                        <a:srgbClr val="C3D1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>
                          <a:solidFill>
                            <a:srgbClr val="40404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CSF1R</a:t>
                      </a:r>
                    </a:p>
                  </a:txBody>
                  <a:tcPr marL="8368" marR="8368" marT="8368" marB="0" anchor="ctr">
                    <a:lnL w="6350" cap="flat" cmpd="sng" algn="ctr">
                      <a:solidFill>
                        <a:srgbClr val="C3D1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C3D1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>
                          <a:solidFill>
                            <a:srgbClr val="40404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FANCD2</a:t>
                      </a:r>
                    </a:p>
                  </a:txBody>
                  <a:tcPr marL="8368" marR="8368" marT="8368" marB="0" anchor="ctr">
                    <a:lnL w="6350" cap="flat" cmpd="sng" algn="ctr">
                      <a:solidFill>
                        <a:srgbClr val="C3D1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C3D1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>
                          <a:solidFill>
                            <a:srgbClr val="40404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HIST1H3B</a:t>
                      </a:r>
                    </a:p>
                  </a:txBody>
                  <a:tcPr marL="8368" marR="8368" marT="8368" marB="0" anchor="ctr">
                    <a:lnL w="6350" cap="flat" cmpd="sng" algn="ctr">
                      <a:solidFill>
                        <a:srgbClr val="C3D1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C3D1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>
                          <a:solidFill>
                            <a:srgbClr val="40404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MAP2K4</a:t>
                      </a:r>
                    </a:p>
                  </a:txBody>
                  <a:tcPr marL="8368" marR="8368" marT="8368" marB="0" anchor="ctr">
                    <a:lnL w="6350" cap="flat" cmpd="sng" algn="ctr">
                      <a:solidFill>
                        <a:srgbClr val="C3D1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C3D1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>
                          <a:solidFill>
                            <a:srgbClr val="40404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NPM1</a:t>
                      </a:r>
                    </a:p>
                  </a:txBody>
                  <a:tcPr marL="8368" marR="8368" marT="8368" marB="0" anchor="ctr">
                    <a:lnL w="6350" cap="flat" cmpd="sng" algn="ctr">
                      <a:solidFill>
                        <a:srgbClr val="C3D1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C3D1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>
                          <a:solidFill>
                            <a:srgbClr val="40404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SDHB</a:t>
                      </a:r>
                    </a:p>
                  </a:txBody>
                  <a:tcPr marL="8368" marR="8368" marT="8368" marB="0" anchor="ctr">
                    <a:lnL w="6350" cap="flat" cmpd="sng" algn="ctr">
                      <a:solidFill>
                        <a:srgbClr val="C3D1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C3D1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>
                          <a:solidFill>
                            <a:srgbClr val="40404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VHL</a:t>
                      </a:r>
                    </a:p>
                  </a:txBody>
                  <a:tcPr marL="8368" marR="8368" marT="8368" marB="0" anchor="ctr">
                    <a:lnL w="6350" cap="flat" cmpd="sng" algn="ctr">
                      <a:solidFill>
                        <a:srgbClr val="C3D1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5"/>
                  </a:ext>
                </a:extLst>
              </a:tr>
              <a:tr h="235029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>
                          <a:solidFill>
                            <a:srgbClr val="40404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BRCA1</a:t>
                      </a:r>
                    </a:p>
                  </a:txBody>
                  <a:tcPr marL="8368" marR="8368" marT="8368" marB="0" anchor="ctr">
                    <a:lnL>
                      <a:noFill/>
                    </a:lnL>
                    <a:lnR w="6350" cap="flat" cmpd="sng" algn="ctr">
                      <a:solidFill>
                        <a:srgbClr val="C3D1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9EEF2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>
                          <a:solidFill>
                            <a:srgbClr val="40404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CTNNB1</a:t>
                      </a:r>
                    </a:p>
                  </a:txBody>
                  <a:tcPr marL="8368" marR="8368" marT="8368" marB="0" anchor="ctr">
                    <a:lnL w="6350" cap="flat" cmpd="sng" algn="ctr">
                      <a:solidFill>
                        <a:srgbClr val="C3D1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C3D1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9EEF2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>
                          <a:solidFill>
                            <a:srgbClr val="40404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FANCE</a:t>
                      </a:r>
                    </a:p>
                  </a:txBody>
                  <a:tcPr marL="8368" marR="8368" marT="8368" marB="0" anchor="ctr">
                    <a:lnL w="6350" cap="flat" cmpd="sng" algn="ctr">
                      <a:solidFill>
                        <a:srgbClr val="C3D1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C3D1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9EEF2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>
                          <a:solidFill>
                            <a:srgbClr val="40404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HNF1A</a:t>
                      </a:r>
                    </a:p>
                  </a:txBody>
                  <a:tcPr marL="8368" marR="8368" marT="8368" marB="0" anchor="ctr">
                    <a:lnL w="6350" cap="flat" cmpd="sng" algn="ctr">
                      <a:solidFill>
                        <a:srgbClr val="C3D1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C3D1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9EEF2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>
                          <a:solidFill>
                            <a:srgbClr val="40404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MAP3K1</a:t>
                      </a:r>
                    </a:p>
                  </a:txBody>
                  <a:tcPr marL="8368" marR="8368" marT="8368" marB="0" anchor="ctr">
                    <a:lnL w="6350" cap="flat" cmpd="sng" algn="ctr">
                      <a:solidFill>
                        <a:srgbClr val="C3D1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C3D1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9EEF2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>
                          <a:solidFill>
                            <a:srgbClr val="40404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NRAS</a:t>
                      </a:r>
                    </a:p>
                  </a:txBody>
                  <a:tcPr marL="8368" marR="8368" marT="8368" marB="0" anchor="ctr">
                    <a:lnL w="6350" cap="flat" cmpd="sng" algn="ctr">
                      <a:solidFill>
                        <a:srgbClr val="C3D1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C3D1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9EEF2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>
                          <a:solidFill>
                            <a:srgbClr val="40404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SETD2</a:t>
                      </a:r>
                    </a:p>
                  </a:txBody>
                  <a:tcPr marL="8368" marR="8368" marT="8368" marB="0" anchor="ctr">
                    <a:lnL w="6350" cap="flat" cmpd="sng" algn="ctr">
                      <a:solidFill>
                        <a:srgbClr val="C3D1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C3D1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9EEF2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>
                          <a:solidFill>
                            <a:srgbClr val="40404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WT1</a:t>
                      </a:r>
                    </a:p>
                  </a:txBody>
                  <a:tcPr marL="8368" marR="8368" marT="8368" marB="0" anchor="ctr">
                    <a:lnL w="6350" cap="flat" cmpd="sng" algn="ctr">
                      <a:solidFill>
                        <a:srgbClr val="C3D1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9EEF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6"/>
                  </a:ext>
                </a:extLst>
              </a:tr>
              <a:tr h="235029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>
                          <a:solidFill>
                            <a:srgbClr val="40404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BRCA2</a:t>
                      </a:r>
                    </a:p>
                  </a:txBody>
                  <a:tcPr marL="8368" marR="8368" marT="8368" marB="0" anchor="ctr">
                    <a:lnL>
                      <a:noFill/>
                    </a:lnL>
                    <a:lnR w="6350" cap="flat" cmpd="sng" algn="ctr">
                      <a:solidFill>
                        <a:srgbClr val="C3D1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>
                          <a:solidFill>
                            <a:srgbClr val="40404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CYLD</a:t>
                      </a:r>
                    </a:p>
                  </a:txBody>
                  <a:tcPr marL="8368" marR="8368" marT="8368" marB="0" anchor="ctr">
                    <a:lnL w="6350" cap="flat" cmpd="sng" algn="ctr">
                      <a:solidFill>
                        <a:srgbClr val="C3D1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C3D1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>
                          <a:solidFill>
                            <a:srgbClr val="40404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FAS</a:t>
                      </a:r>
                    </a:p>
                  </a:txBody>
                  <a:tcPr marL="8368" marR="8368" marT="8368" marB="0" anchor="ctr">
                    <a:lnL w="6350" cap="flat" cmpd="sng" algn="ctr">
                      <a:solidFill>
                        <a:srgbClr val="C3D1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C3D1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>
                          <a:solidFill>
                            <a:srgbClr val="40404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HRAS</a:t>
                      </a:r>
                    </a:p>
                  </a:txBody>
                  <a:tcPr marL="8368" marR="8368" marT="8368" marB="0" anchor="ctr">
                    <a:lnL w="6350" cap="flat" cmpd="sng" algn="ctr">
                      <a:solidFill>
                        <a:srgbClr val="C3D1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C3D1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>
                          <a:solidFill>
                            <a:srgbClr val="40404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MAP4K3</a:t>
                      </a:r>
                    </a:p>
                  </a:txBody>
                  <a:tcPr marL="8368" marR="8368" marT="8368" marB="0" anchor="ctr">
                    <a:lnL w="6350" cap="flat" cmpd="sng" algn="ctr">
                      <a:solidFill>
                        <a:srgbClr val="C3D1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C3D1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>
                          <a:solidFill>
                            <a:srgbClr val="40404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PALB2</a:t>
                      </a:r>
                    </a:p>
                  </a:txBody>
                  <a:tcPr marL="8368" marR="8368" marT="8368" marB="0" anchor="ctr">
                    <a:lnL w="6350" cap="flat" cmpd="sng" algn="ctr">
                      <a:solidFill>
                        <a:srgbClr val="C3D1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C3D1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>
                          <a:solidFill>
                            <a:srgbClr val="40404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SF3B1</a:t>
                      </a:r>
                    </a:p>
                  </a:txBody>
                  <a:tcPr marL="8368" marR="8368" marT="8368" marB="0" anchor="ctr">
                    <a:lnL w="6350" cap="flat" cmpd="sng" algn="ctr">
                      <a:solidFill>
                        <a:srgbClr val="C3D1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C3D1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>
                          <a:solidFill>
                            <a:srgbClr val="40404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XPC</a:t>
                      </a:r>
                    </a:p>
                  </a:txBody>
                  <a:tcPr marL="8368" marR="8368" marT="8368" marB="0" anchor="ctr">
                    <a:lnL w="6350" cap="flat" cmpd="sng" algn="ctr">
                      <a:solidFill>
                        <a:srgbClr val="C3D1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7"/>
                  </a:ext>
                </a:extLst>
              </a:tr>
              <a:tr h="235029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>
                          <a:solidFill>
                            <a:srgbClr val="40404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BRIP1</a:t>
                      </a:r>
                    </a:p>
                  </a:txBody>
                  <a:tcPr marL="8368" marR="8368" marT="8368" marB="0" anchor="ctr">
                    <a:lnL>
                      <a:noFill/>
                    </a:lnL>
                    <a:lnR w="6350" cap="flat" cmpd="sng" algn="ctr">
                      <a:solidFill>
                        <a:srgbClr val="C3D1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9EEF2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>
                          <a:solidFill>
                            <a:srgbClr val="40404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DAXX</a:t>
                      </a:r>
                    </a:p>
                  </a:txBody>
                  <a:tcPr marL="8368" marR="8368" marT="8368" marB="0" anchor="ctr">
                    <a:lnL w="6350" cap="flat" cmpd="sng" algn="ctr">
                      <a:solidFill>
                        <a:srgbClr val="C3D1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C3D1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9EEF2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>
                          <a:solidFill>
                            <a:srgbClr val="40404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FBXO11</a:t>
                      </a:r>
                    </a:p>
                  </a:txBody>
                  <a:tcPr marL="8368" marR="8368" marT="8368" marB="0" anchor="ctr">
                    <a:lnL w="6350" cap="flat" cmpd="sng" algn="ctr">
                      <a:solidFill>
                        <a:srgbClr val="C3D1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C3D1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9EEF2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>
                          <a:solidFill>
                            <a:srgbClr val="40404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HSPH1</a:t>
                      </a:r>
                    </a:p>
                  </a:txBody>
                  <a:tcPr marL="8368" marR="8368" marT="8368" marB="0" anchor="ctr">
                    <a:lnL w="6350" cap="flat" cmpd="sng" algn="ctr">
                      <a:solidFill>
                        <a:srgbClr val="C3D1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C3D1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9EEF2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>
                          <a:solidFill>
                            <a:srgbClr val="40404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MDM2</a:t>
                      </a:r>
                    </a:p>
                  </a:txBody>
                  <a:tcPr marL="8368" marR="8368" marT="8368" marB="0" anchor="ctr">
                    <a:lnL w="6350" cap="flat" cmpd="sng" algn="ctr">
                      <a:solidFill>
                        <a:srgbClr val="C3D1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C3D1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9EEF2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>
                          <a:solidFill>
                            <a:srgbClr val="40404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PAX5</a:t>
                      </a:r>
                    </a:p>
                  </a:txBody>
                  <a:tcPr marL="8368" marR="8368" marT="8368" marB="0" anchor="ctr">
                    <a:lnL w="6350" cap="flat" cmpd="sng" algn="ctr">
                      <a:solidFill>
                        <a:srgbClr val="C3D1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C3D1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9EEF2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>
                          <a:solidFill>
                            <a:srgbClr val="40404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SLC7A8</a:t>
                      </a:r>
                    </a:p>
                  </a:txBody>
                  <a:tcPr marL="8368" marR="8368" marT="8368" marB="0" anchor="ctr">
                    <a:lnL w="6350" cap="flat" cmpd="sng" algn="ctr">
                      <a:solidFill>
                        <a:srgbClr val="C3D1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C3D1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9EEF2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>
                          <a:solidFill>
                            <a:srgbClr val="40404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ZNF2</a:t>
                      </a:r>
                    </a:p>
                  </a:txBody>
                  <a:tcPr marL="8368" marR="8368" marT="8368" marB="0" anchor="ctr">
                    <a:lnL w="6350" cap="flat" cmpd="sng" algn="ctr">
                      <a:solidFill>
                        <a:srgbClr val="C3D1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9EEF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8"/>
                  </a:ext>
                </a:extLst>
              </a:tr>
              <a:tr h="235029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>
                          <a:solidFill>
                            <a:srgbClr val="40404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BTK</a:t>
                      </a:r>
                    </a:p>
                  </a:txBody>
                  <a:tcPr marL="8368" marR="8368" marT="8368" marB="0" anchor="ctr">
                    <a:lnL>
                      <a:noFill/>
                    </a:lnL>
                    <a:lnR w="6350" cap="flat" cmpd="sng" algn="ctr">
                      <a:solidFill>
                        <a:srgbClr val="C3D1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 dirty="0">
                          <a:solidFill>
                            <a:srgbClr val="40404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DDB2</a:t>
                      </a:r>
                    </a:p>
                  </a:txBody>
                  <a:tcPr marL="8368" marR="8368" marT="8368" marB="0" anchor="ctr">
                    <a:lnL w="6350" cap="flat" cmpd="sng" algn="ctr">
                      <a:solidFill>
                        <a:srgbClr val="C3D1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C3D1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>
                          <a:solidFill>
                            <a:srgbClr val="40404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FBXW7</a:t>
                      </a:r>
                    </a:p>
                  </a:txBody>
                  <a:tcPr marL="8368" marR="8368" marT="8368" marB="0" anchor="ctr">
                    <a:lnL w="6350" cap="flat" cmpd="sng" algn="ctr">
                      <a:solidFill>
                        <a:srgbClr val="C3D1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C3D1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>
                          <a:solidFill>
                            <a:srgbClr val="40404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IDH1</a:t>
                      </a:r>
                    </a:p>
                  </a:txBody>
                  <a:tcPr marL="8368" marR="8368" marT="8368" marB="0" anchor="ctr">
                    <a:lnL w="6350" cap="flat" cmpd="sng" algn="ctr">
                      <a:solidFill>
                        <a:srgbClr val="C3D1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C3D1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>
                          <a:solidFill>
                            <a:srgbClr val="40404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MED12</a:t>
                      </a:r>
                    </a:p>
                  </a:txBody>
                  <a:tcPr marL="8368" marR="8368" marT="8368" marB="0" anchor="ctr">
                    <a:lnL w="6350" cap="flat" cmpd="sng" algn="ctr">
                      <a:solidFill>
                        <a:srgbClr val="C3D1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C3D1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>
                          <a:solidFill>
                            <a:srgbClr val="40404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PBRM1</a:t>
                      </a:r>
                    </a:p>
                  </a:txBody>
                  <a:tcPr marL="8368" marR="8368" marT="8368" marB="0" anchor="ctr">
                    <a:lnL w="6350" cap="flat" cmpd="sng" algn="ctr">
                      <a:solidFill>
                        <a:srgbClr val="C3D1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C3D1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>
                          <a:solidFill>
                            <a:srgbClr val="40404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SMAD4</a:t>
                      </a:r>
                    </a:p>
                  </a:txBody>
                  <a:tcPr marL="8368" marR="8368" marT="8368" marB="0" anchor="ctr">
                    <a:lnL w="6350" cap="flat" cmpd="sng" algn="ctr">
                      <a:solidFill>
                        <a:srgbClr val="C3D1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C3D1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 dirty="0">
                          <a:solidFill>
                            <a:srgbClr val="40404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ZRSR2</a:t>
                      </a:r>
                    </a:p>
                  </a:txBody>
                  <a:tcPr marL="8368" marR="8368" marT="8368" marB="0" anchor="ctr">
                    <a:lnL w="6350" cap="flat" cmpd="sng" algn="ctr">
                      <a:solidFill>
                        <a:srgbClr val="C3D1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E5EFFA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9"/>
                  </a:ext>
                </a:extLst>
              </a:tr>
            </a:tbl>
          </a:graphicData>
        </a:graphic>
      </p:graphicFrame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586D3F1C-89EB-43BF-B9E7-3E0D3D4D6FFA}"/>
              </a:ext>
            </a:extLst>
          </p:cNvPr>
          <p:cNvSpPr txBox="1"/>
          <p:nvPr/>
        </p:nvSpPr>
        <p:spPr>
          <a:xfrm>
            <a:off x="2408430" y="770933"/>
            <a:ext cx="6093724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400" kern="12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HG丸ｺﾞｼｯｸM-PRO" panose="020F0600000000000000" pitchFamily="50" charset="-128"/>
                <a:cs typeface="Meiryo UI" panose="020B0604030504040204" pitchFamily="50" charset="-128"/>
              </a:rPr>
              <a:t>Figure S1. Comprehensive Cancer Panel: 160 gene list</a:t>
            </a:r>
            <a:endParaRPr lang="ja-JP" altLang="en-US" sz="1400" dirty="0"/>
          </a:p>
        </p:txBody>
      </p:sp>
    </p:spTree>
    <p:extLst>
      <p:ext uri="{BB962C8B-B14F-4D97-AF65-F5344CB8AC3E}">
        <p14:creationId xmlns:p14="http://schemas.microsoft.com/office/powerpoint/2010/main" val="101533886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表 1"/>
          <p:cNvGraphicFramePr>
            <a:graphicFrameLocks noGrp="1"/>
          </p:cNvGraphicFramePr>
          <p:nvPr/>
        </p:nvGraphicFramePr>
        <p:xfrm>
          <a:off x="2038350" y="1715294"/>
          <a:ext cx="7762875" cy="3009108"/>
        </p:xfrm>
        <a:graphic>
          <a:graphicData uri="http://schemas.openxmlformats.org/drawingml/2006/table">
            <a:tbl>
              <a:tblPr/>
              <a:tblGrid>
                <a:gridCol w="646906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7115969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</a:tblGrid>
              <a:tr h="752277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Level A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Biomarkers that predict response or resistance to US FDA‐approved therapies for a specific type of tumor or have been included in professional guidelines as therapeutic, diagnostic, and/or prognostic biomarkers for specific types of tumors.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752277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Level B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Biomarkers that predict response or resistance to a therapy based on well‐powered studies with consensus from experts in the field, or have diagnostic and/or prognostic significance of certain diseases based on well‐powered studies with expert consensus.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752277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Level C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Biomarkers that predict response or resistance to therapies approved by FDA or professional societies for a different tumor type (</a:t>
                      </a:r>
                      <a:r>
                        <a:rPr lang="en-US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ie</a:t>
                      </a: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, off‐label use of a drug), serve as inclusion criteria for clinical trials, or have diagnostic and/or prognostic significance based on the results of multiple small studies.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752277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Level D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Biomarkers that show plausible therapeutic significance based on preclinical studies, or may assist disease diagnosis and/or prognosis themselves or along with other biomarkers based on small studies or multiple case reports with no consensus.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</a:tbl>
          </a:graphicData>
        </a:graphic>
      </p:graphicFrame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00CBF266-DD1C-4759-82D3-89066950EAC0}"/>
              </a:ext>
            </a:extLst>
          </p:cNvPr>
          <p:cNvSpPr txBox="1"/>
          <p:nvPr/>
        </p:nvSpPr>
        <p:spPr>
          <a:xfrm>
            <a:off x="2038350" y="1418290"/>
            <a:ext cx="7980529" cy="29700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95000"/>
              </a:lnSpc>
            </a:pPr>
            <a:r>
              <a:rPr lang="en-US" altLang="ja-JP" sz="14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Figure S2. Criteria and categories of genotype-matched therapy based on clinical sequencing</a:t>
            </a:r>
            <a:endParaRPr lang="ja-JP" altLang="ja-JP" sz="1400" dirty="0">
              <a:solidFill>
                <a:srgbClr val="000000"/>
              </a:solidFill>
              <a:effectLst/>
              <a:latin typeface="Palatino Linotype" panose="02040502050505030304" pitchFamily="18" charset="0"/>
              <a:ea typeface="SimSun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1322341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8</TotalTime>
  <Words>369</Words>
  <Application>Microsoft Office PowerPoint</Application>
  <PresentationFormat>ワイド画面</PresentationFormat>
  <Paragraphs>170</Paragraphs>
  <Slides>2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Palatino Linotype</vt:lpstr>
      <vt:lpstr>Office テーマ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MR7300 SSD</dc:creator>
  <cp:lastModifiedBy>Sultana Razia</cp:lastModifiedBy>
  <cp:revision>10</cp:revision>
  <dcterms:created xsi:type="dcterms:W3CDTF">2021-03-08T05:21:13Z</dcterms:created>
  <dcterms:modified xsi:type="dcterms:W3CDTF">2021-09-06T09:59:06Z</dcterms:modified>
</cp:coreProperties>
</file>